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7589" autoAdjust="0"/>
  </p:normalViewPr>
  <p:slideViewPr>
    <p:cSldViewPr snapToObjects="1">
      <p:cViewPr>
        <p:scale>
          <a:sx n="174" d="100"/>
          <a:sy n="174" d="100"/>
        </p:scale>
        <p:origin x="-168" y="23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CCE54-B628-0D48-9B5F-FF3843CAED00}" type="datetimeFigureOut">
              <a:rPr lang="fr-FR" smtClean="0"/>
              <a:pPr/>
              <a:t>5/5/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74892-8B56-914C-95D4-4B5FCDA97B8D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3"/>
          <p:cNvSpPr txBox="1"/>
          <p:nvPr/>
        </p:nvSpPr>
        <p:spPr>
          <a:xfrm>
            <a:off x="-76200" y="1484784"/>
            <a:ext cx="9753600" cy="332398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fr-FR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Homo sapiens 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	TGGGGCCTCTTTGGC</a:t>
            </a:r>
            <a:r>
              <a:rPr lang="fr-FR" sz="1400" b="1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AAAACAGGAAAAGCACCAGGATTTTCTTATACAGAGGCAAACAAAAAC</a:t>
            </a:r>
          </a:p>
          <a:p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Gorilla</a:t>
            </a:r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gorilla</a:t>
            </a:r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	TGGGGCCTCTTTGGC</a:t>
            </a:r>
            <a:r>
              <a:rPr lang="fr-FR" sz="1400" b="1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AAAACAGGAAAAGCACCAGGATTTTCTTATACAGAGGCAAACAAAAAC</a:t>
            </a:r>
          </a:p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Pan troglodytes 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	TGGGGCCTCTTTGGC</a:t>
            </a:r>
            <a:r>
              <a:rPr lang="fr-FR" sz="1400" b="1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AAAACAGGAAAAGCACCAGGATTTTCTTATACAGAGGCAAACAAAAAC</a:t>
            </a:r>
          </a:p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Pongo </a:t>
            </a:r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pygmaeus</a:t>
            </a:r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	TGGGGCCTCTTTGGC</a:t>
            </a:r>
            <a:r>
              <a:rPr lang="fr-FR" sz="1400" b="1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AAAACAGGAAAAGCACCAGGATTTTCTTATACAGAGGCAAACAAAAAC</a:t>
            </a:r>
          </a:p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H. </a:t>
            </a:r>
            <a:r>
              <a:rPr lang="fr-FR" sz="1400" i="1" smtClean="0">
                <a:solidFill>
                  <a:srgbClr val="465466"/>
                </a:solidFill>
                <a:latin typeface="Courier"/>
                <a:cs typeface="Courier"/>
              </a:rPr>
              <a:t>syndactyl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	</a:t>
            </a:r>
            <a:r>
              <a:rPr lang="fr-FR" sz="1400" cap="all" dirty="0" smtClean="0">
                <a:solidFill>
                  <a:srgbClr val="465466"/>
                </a:solidFill>
                <a:latin typeface="Courier"/>
                <a:cs typeface="Courier"/>
              </a:rPr>
              <a:t>tggggcctctttggc</a:t>
            </a:r>
            <a:r>
              <a:rPr lang="fr-FR" sz="1400" b="1" cap="all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cap="all" dirty="0" smtClean="0">
                <a:solidFill>
                  <a:srgbClr val="465466"/>
                </a:solidFill>
                <a:latin typeface="Courier"/>
                <a:cs typeface="Courier"/>
              </a:rPr>
              <a:t>aaaacaggacaagcaccaggattttcttatacagaggcaaacaaagac</a:t>
            </a:r>
            <a:endParaRPr lang="fr-FR" sz="1400" i="1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Macaca</a:t>
            </a:r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mulatta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		TGGGGCCTCTTTGAC</a:t>
            </a:r>
            <a:r>
              <a:rPr lang="fr-FR" sz="1400" b="1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AAAACAGGACAAACACCAGGATTTTCTTGTGCAGAGGCAAACAAAAAC</a:t>
            </a:r>
          </a:p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M. </a:t>
            </a:r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sylvanus</a:t>
            </a:r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			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gggcctctttgac</a:t>
            </a:r>
            <a:r>
              <a:rPr lang="fr-FR" sz="1400" b="1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aaaacaggacaaacaccaggattttcttgtgcagaggcaaacaaaaac</a:t>
            </a:r>
            <a:endParaRPr lang="fr-FR" sz="1400" cap="all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C. </a:t>
            </a:r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guereza</a:t>
            </a:r>
            <a:r>
              <a:rPr lang="fr-FR" sz="1400" cap="all" dirty="0" smtClean="0">
                <a:solidFill>
                  <a:srgbClr val="465466"/>
                </a:solidFill>
                <a:latin typeface="Courier"/>
                <a:cs typeface="Courier"/>
              </a:rPr>
              <a:t>			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ggacctctttgac</a:t>
            </a:r>
            <a:r>
              <a:rPr lang="fr-FR" sz="1400" b="1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aaaacgggacaaacaccagcattttcttatacagaggcaaacaaaaac</a:t>
            </a:r>
            <a:endParaRPr lang="fr-FR" sz="1400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L. </a:t>
            </a:r>
            <a:r>
              <a:rPr lang="fr-FR" sz="1400" i="1" dirty="0" err="1" smtClean="0">
                <a:solidFill>
                  <a:srgbClr val="465466"/>
                </a:solidFill>
                <a:latin typeface="Courier"/>
                <a:cs typeface="Courier"/>
              </a:rPr>
              <a:t>aterrimus</a:t>
            </a:r>
            <a:r>
              <a:rPr lang="fr-FR" sz="1400" i="1" dirty="0" smtClean="0">
                <a:solidFill>
                  <a:srgbClr val="465466"/>
                </a:solidFill>
                <a:latin typeface="Courier"/>
                <a:cs typeface="Courier"/>
              </a:rPr>
              <a:t>			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gggcctctttgac</a:t>
            </a:r>
            <a:r>
              <a:rPr lang="fr-FR" sz="1400" b="1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aaaacaggacaaacaccaggattttcttgtacNgaggcaaacaaaaac</a:t>
            </a:r>
            <a:endParaRPr lang="fr-FR" sz="1400" cap="all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Callithrix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jacch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agaC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CTCTTaGGC</a:t>
            </a:r>
            <a:r>
              <a:rPr lang="fr-FR" sz="1400" b="1" dirty="0" err="1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AAAACAGGAcAAGCACCAGGATTTTCTTATACAGAGGCAAACAAAAAC</a:t>
            </a:r>
            <a:endParaRPr lang="fr-FR" sz="1400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S. 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labiat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			</a:t>
            </a:r>
            <a:r>
              <a:rPr lang="fr-FR" sz="1400" cap="all" dirty="0" smtClean="0">
                <a:solidFill>
                  <a:srgbClr val="465466"/>
                </a:solidFill>
                <a:latin typeface="Courier"/>
                <a:cs typeface="Courier"/>
              </a:rPr>
              <a:t>tggggcctctttggc</a:t>
            </a:r>
            <a:r>
              <a:rPr lang="fr-FR" sz="1400" b="1" cap="all" dirty="0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cap="all" dirty="0" smtClean="0">
                <a:solidFill>
                  <a:srgbClr val="465466"/>
                </a:solidFill>
                <a:latin typeface="Courier"/>
                <a:cs typeface="Courier"/>
              </a:rPr>
              <a:t>aaaacaggacaagcaccaggattttcttatacagaggcagacaaaaac</a:t>
            </a:r>
            <a:endParaRPr lang="fr-FR" sz="1400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200" dirty="0" err="1" smtClean="0">
                <a:solidFill>
                  <a:srgbClr val="465466"/>
                </a:solidFill>
                <a:latin typeface="Courier"/>
                <a:cs typeface="Courier"/>
              </a:rPr>
              <a:t>Daubentia</a:t>
            </a:r>
            <a:r>
              <a:rPr lang="fr-FR" sz="1200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200" dirty="0" err="1" smtClean="0">
                <a:solidFill>
                  <a:srgbClr val="465466"/>
                </a:solidFill>
                <a:latin typeface="Courier"/>
                <a:cs typeface="Courier"/>
              </a:rPr>
              <a:t>madagascarensis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gggcctctttggc</a:t>
            </a:r>
            <a:r>
              <a:rPr lang="fr-FR" sz="1400" b="1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tga</a:t>
            </a:r>
            <a:r>
              <a:rPr lang="fr-FR" sz="1400" cap="all" dirty="0" err="1" smtClean="0">
                <a:solidFill>
                  <a:srgbClr val="465466"/>
                </a:solidFill>
                <a:latin typeface="Courier"/>
                <a:cs typeface="Courier"/>
              </a:rPr>
              <a:t>aaaacaggagcaagccccaggattt---------------------</a:t>
            </a:r>
            <a:endParaRPr lang="fr-FR" sz="1400" dirty="0" smtClean="0">
              <a:solidFill>
                <a:srgbClr val="465466"/>
              </a:solidFill>
              <a:latin typeface="Courier"/>
              <a:cs typeface="Courier"/>
            </a:endParaRPr>
          </a:p>
          <a:p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Mus 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muscul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		TGGGGCCTCTTTGGTCGAAAGACAGGACAAGCACCAGGATTTTCTTACACGGATGCAAACAAGAAC</a:t>
            </a:r>
          </a:p>
          <a:p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Ratt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norvegic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	TGGGGCCTTTTTGGCCGAAAGACTGGACAAGCACCAGGATTTTCTTACACGGATGCAAACAAGAAC</a:t>
            </a:r>
          </a:p>
          <a:p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Equ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</a:t>
            </a:r>
            <a:r>
              <a:rPr lang="fr-FR" sz="1400" dirty="0" err="1" smtClean="0">
                <a:solidFill>
                  <a:srgbClr val="465466"/>
                </a:solidFill>
                <a:latin typeface="Courier"/>
                <a:cs typeface="Courier"/>
              </a:rPr>
              <a:t>caballus</a:t>
            </a:r>
            <a:r>
              <a:rPr lang="fr-FR" sz="1400" dirty="0" smtClean="0">
                <a:solidFill>
                  <a:srgbClr val="465466"/>
                </a:solidFill>
                <a:latin typeface="Courier"/>
                <a:cs typeface="Courier"/>
              </a:rPr>
              <a:t> 		TGGGGCCTTTTTGGCCGAAAAACAGGACAAGCACCAGGATTTTCTTACTCTGATGCAAACAAAAAC</a:t>
            </a:r>
          </a:p>
        </p:txBody>
      </p:sp>
      <p:sp>
        <p:nvSpPr>
          <p:cNvPr id="2" name="Rectangle 1"/>
          <p:cNvSpPr/>
          <p:nvPr/>
        </p:nvSpPr>
        <p:spPr>
          <a:xfrm>
            <a:off x="1475656" y="461328"/>
            <a:ext cx="72728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equence of testis cytochrome </a:t>
            </a:r>
            <a:r>
              <a:rPr lang="en-US" b="1" i="1" dirty="0"/>
              <a:t>c</a:t>
            </a:r>
            <a:r>
              <a:rPr lang="en-US" b="1" dirty="0"/>
              <a:t>  </a:t>
            </a:r>
            <a:r>
              <a:rPr lang="en-US" dirty="0"/>
              <a:t>(TGA mutation is in bold)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4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ENIS PIERRON</dc:creator>
  <cp:lastModifiedBy>Denis Pierron</cp:lastModifiedBy>
  <cp:revision>5</cp:revision>
  <dcterms:created xsi:type="dcterms:W3CDTF">2010-08-27T19:42:05Z</dcterms:created>
  <dcterms:modified xsi:type="dcterms:W3CDTF">2011-05-05T14:34:00Z</dcterms:modified>
</cp:coreProperties>
</file>